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0C0AA-5890-45AE-BE46-EB33458259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8A932F-23B5-4572-A3E1-E46703CD2F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6F8DA2-33D5-4601-A340-86379A9282C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252E40-8290-48E1-AD43-5D918636437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6512F6-0F41-4419-A6F7-5E63F75CBE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139789-924D-4740-AB36-629FF770F4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9BB828-CF57-4AAC-85C1-B33DEB0A3A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6E31AA-B2A0-4F61-BF2B-A632C305C5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561B79-531D-45D0-B121-C0B64264B0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8BAA99-D2BC-4C38-90E7-1BB4F3A46F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ACC169-20BB-4FCB-9226-48DE7AE632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4ECE3A-F19E-4ACF-9B29-1A0D30F790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0D6D44-624D-4C7A-A2A3-694D094E652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odelled influence on global CCN of different organic growth rates from 1.7 nm to 3 nm simulated by the GLOMAP aerosol mod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2171880" y="2587680"/>
            <a:ext cx="4800600" cy="17128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D:\PPT_Out\nature-logo.jpg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J Tröstl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et al. Natur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33,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27–531 (2016) doi:10.1038/nature1827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18T09:41:10Z</dcterms:created>
  <dc:creator>ravikumar.n</dc:creator>
  <dc:description/>
  <dc:language>en-US</dc:language>
  <cp:lastModifiedBy>R.Vijitha</cp:lastModifiedBy>
  <dcterms:modified xsi:type="dcterms:W3CDTF">2016-05-18T09:42:29Z</dcterms:modified>
  <cp:revision>2</cp:revision>
  <dc:subject/>
  <dc:title>Modelled influence on global CCN of different organic growth rates from 1.7 nm to 3 nm simulated by the GLOMAP aerosol model</dc:title>
</cp:coreProperties>
</file>